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9" y="8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BEF79-44EF-4BFB-ACB4-64E8D3C849C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AAC0-08F7-4AA2-8F7B-27D49D4B32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120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BEF79-44EF-4BFB-ACB4-64E8D3C849C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AAC0-08F7-4AA2-8F7B-27D49D4B32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656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BEF79-44EF-4BFB-ACB4-64E8D3C849C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AAC0-08F7-4AA2-8F7B-27D49D4B32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2172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BEF79-44EF-4BFB-ACB4-64E8D3C849C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AAC0-08F7-4AA2-8F7B-27D49D4B32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841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BEF79-44EF-4BFB-ACB4-64E8D3C849C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AAC0-08F7-4AA2-8F7B-27D49D4B32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345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BEF79-44EF-4BFB-ACB4-64E8D3C849C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AAC0-08F7-4AA2-8F7B-27D49D4B32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011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BEF79-44EF-4BFB-ACB4-64E8D3C849C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AAC0-08F7-4AA2-8F7B-27D49D4B32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0607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BEF79-44EF-4BFB-ACB4-64E8D3C849C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AAC0-08F7-4AA2-8F7B-27D49D4B32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3055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BEF79-44EF-4BFB-ACB4-64E8D3C849C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AAC0-08F7-4AA2-8F7B-27D49D4B32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4222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BEF79-44EF-4BFB-ACB4-64E8D3C849C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AAC0-08F7-4AA2-8F7B-27D49D4B32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19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BEF79-44EF-4BFB-ACB4-64E8D3C849C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AAC0-08F7-4AA2-8F7B-27D49D4B32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352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6BEF79-44EF-4BFB-ACB4-64E8D3C849C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D3AAC0-08F7-4AA2-8F7B-27D49D4B32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447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2744" y="548640"/>
            <a:ext cx="8947602" cy="5261179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802105" y="5809819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12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log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)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log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)) for deprotected chloroquinolines against sensitive strain K1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7936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07:50Z</dcterms:created>
  <dcterms:modified xsi:type="dcterms:W3CDTF">2020-08-04T16:33:02Z</dcterms:modified>
</cp:coreProperties>
</file>